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92" r:id="rId2"/>
    <p:sldId id="293" r:id="rId3"/>
    <p:sldId id="294" r:id="rId4"/>
    <p:sldId id="295" r:id="rId5"/>
  </p:sldIdLst>
  <p:sldSz cx="12192000" cy="7772400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40445"/>
    <a:srgbClr val="3C1C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 autoAdjust="0"/>
    <p:restoredTop sz="98287" autoAdjust="0"/>
  </p:normalViewPr>
  <p:slideViewPr>
    <p:cSldViewPr snapToGrid="0">
      <p:cViewPr>
        <p:scale>
          <a:sx n="70" d="100"/>
          <a:sy n="70" d="100"/>
        </p:scale>
        <p:origin x="-1051" y="-413"/>
      </p:cViewPr>
      <p:guideLst>
        <p:guide orient="horz" pos="2449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FABE69-1E0A-4574-A649-E0734A7515EE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79425" y="744538"/>
            <a:ext cx="5840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40363" cy="44688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21F534-534B-4480-8E10-8B09B761BC8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140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72013"/>
            <a:ext cx="9144000" cy="270594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82311"/>
            <a:ext cx="9144000" cy="187653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909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087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13811"/>
            <a:ext cx="2628900" cy="658674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13811"/>
            <a:ext cx="7734300" cy="658674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285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593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937703"/>
            <a:ext cx="10515600" cy="323310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201393"/>
            <a:ext cx="10515600" cy="1700212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195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2069043"/>
            <a:ext cx="5181600" cy="49315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2069043"/>
            <a:ext cx="5181600" cy="49315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068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13809"/>
            <a:ext cx="10515600" cy="150230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2" y="1905320"/>
            <a:ext cx="51577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2" y="2839085"/>
            <a:ext cx="5157787" cy="41758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05320"/>
            <a:ext cx="51831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39085"/>
            <a:ext cx="5183187" cy="41758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01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560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5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7" y="1119083"/>
            <a:ext cx="6172201" cy="552344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8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7" y="1119083"/>
            <a:ext cx="6172201" cy="552344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0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413809"/>
            <a:ext cx="10515600" cy="150230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2069043"/>
            <a:ext cx="10515600" cy="49315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7203863"/>
            <a:ext cx="27432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7203863"/>
            <a:ext cx="41148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7203863"/>
            <a:ext cx="27432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043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G:\2039x87119 PLATE 5,SAMPLE NO 1 TO 48 26072016 RFQ-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0"/>
          <a:stretch>
            <a:fillRect/>
          </a:stretch>
        </p:blipFill>
        <p:spPr bwMode="auto">
          <a:xfrm>
            <a:off x="2971800" y="0"/>
            <a:ext cx="9144000" cy="5734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/>
          <p:cNvSpPr/>
          <p:nvPr/>
        </p:nvSpPr>
        <p:spPr>
          <a:xfrm>
            <a:off x="0" y="2733095"/>
            <a:ext cx="2884714" cy="646331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CcLG08_RFQI4</a:t>
            </a:r>
          </a:p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ICPA 2039 x ICPL 87119 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3084175" y="520268"/>
            <a:ext cx="1041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PA 203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3259359" y="508000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CPL 8711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4125686" y="777986"/>
            <a:ext cx="7326085" cy="307777"/>
            <a:chOff x="5086878" y="1169882"/>
            <a:chExt cx="5526693" cy="307777"/>
          </a:xfrm>
        </p:grpSpPr>
        <p:sp>
          <p:nvSpPr>
            <p:cNvPr id="11" name="TextBox 10"/>
            <p:cNvSpPr txBox="1"/>
            <p:nvPr/>
          </p:nvSpPr>
          <p:spPr>
            <a:xfrm>
              <a:off x="6641573" y="1169882"/>
              <a:ext cx="11753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1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22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>
              <a:off x="7816895" y="1358739"/>
              <a:ext cx="2796676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Group 13"/>
          <p:cNvGrpSpPr/>
          <p:nvPr/>
        </p:nvGrpSpPr>
        <p:grpSpPr>
          <a:xfrm>
            <a:off x="4660842" y="5665796"/>
            <a:ext cx="6105129" cy="307777"/>
            <a:chOff x="5086878" y="1169882"/>
            <a:chExt cx="5526693" cy="307777"/>
          </a:xfrm>
        </p:grpSpPr>
        <p:sp>
          <p:nvSpPr>
            <p:cNvPr id="15" name="TextBox 14"/>
            <p:cNvSpPr txBox="1"/>
            <p:nvPr/>
          </p:nvSpPr>
          <p:spPr>
            <a:xfrm>
              <a:off x="6641573" y="1169882"/>
              <a:ext cx="1124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23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46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/>
          <p:cNvGrpSpPr/>
          <p:nvPr/>
        </p:nvGrpSpPr>
        <p:grpSpPr>
          <a:xfrm>
            <a:off x="3451038" y="4174453"/>
            <a:ext cx="8087819" cy="571718"/>
            <a:chOff x="5086878" y="1169882"/>
            <a:chExt cx="5526693" cy="307777"/>
          </a:xfrm>
        </p:grpSpPr>
        <p:sp>
          <p:nvSpPr>
            <p:cNvPr id="19" name="TextBox 18"/>
            <p:cNvSpPr txBox="1"/>
            <p:nvPr/>
          </p:nvSpPr>
          <p:spPr>
            <a:xfrm>
              <a:off x="6641573" y="1169882"/>
              <a:ext cx="1124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23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46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Straight Arrow Connector 19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67561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G:\2039x87119 PLATE 5,SAMPLE NO 48 TO 96 27072016 RFQ-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656" y="0"/>
            <a:ext cx="9470075" cy="64116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/>
          <p:cNvSpPr/>
          <p:nvPr/>
        </p:nvSpPr>
        <p:spPr>
          <a:xfrm>
            <a:off x="-65316" y="2733095"/>
            <a:ext cx="2764972" cy="646331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CcLG08_RFQI4</a:t>
            </a:r>
          </a:p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ICPA 2039 x ICPL 87119 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2812032" y="928066"/>
            <a:ext cx="1041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PA 203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3058752" y="889635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CPL 8711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3800943" y="1169882"/>
            <a:ext cx="7901200" cy="307777"/>
            <a:chOff x="5086878" y="1169882"/>
            <a:chExt cx="5526693" cy="307777"/>
          </a:xfrm>
        </p:grpSpPr>
        <p:sp>
          <p:nvSpPr>
            <p:cNvPr id="14" name="TextBox 13"/>
            <p:cNvSpPr txBox="1"/>
            <p:nvPr/>
          </p:nvSpPr>
          <p:spPr>
            <a:xfrm>
              <a:off x="6641573" y="1169882"/>
              <a:ext cx="10869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47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70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7816895" y="1358739"/>
              <a:ext cx="2796676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Group 16"/>
          <p:cNvGrpSpPr/>
          <p:nvPr/>
        </p:nvGrpSpPr>
        <p:grpSpPr>
          <a:xfrm>
            <a:off x="3135086" y="4990882"/>
            <a:ext cx="7990114" cy="307777"/>
            <a:chOff x="5086878" y="1169882"/>
            <a:chExt cx="5526693" cy="307777"/>
          </a:xfrm>
        </p:grpSpPr>
        <p:sp>
          <p:nvSpPr>
            <p:cNvPr id="18" name="TextBox 17"/>
            <p:cNvSpPr txBox="1"/>
            <p:nvPr/>
          </p:nvSpPr>
          <p:spPr>
            <a:xfrm>
              <a:off x="6641573" y="1169882"/>
              <a:ext cx="10693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71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94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65536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G:\2039x87119 PLATE 8,SAMPLE NO 1 TO 48 28072016 RFQ-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1057" y="-1"/>
            <a:ext cx="9711267" cy="64443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5"/>
          <p:cNvSpPr/>
          <p:nvPr/>
        </p:nvSpPr>
        <p:spPr>
          <a:xfrm>
            <a:off x="-65316" y="2733095"/>
            <a:ext cx="2536373" cy="584775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I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cLG08_RFQI4</a:t>
            </a:r>
          </a:p>
          <a:p>
            <a:r>
              <a:rPr lang="en-I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CPA 2039 x ICPL 87119 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2572547" y="967700"/>
            <a:ext cx="1041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PA 203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2827177" y="937552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CPL 8711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3569367" y="1169882"/>
            <a:ext cx="8034803" cy="307777"/>
            <a:chOff x="5086878" y="1169882"/>
            <a:chExt cx="5526693" cy="307777"/>
          </a:xfrm>
        </p:grpSpPr>
        <p:sp>
          <p:nvSpPr>
            <p:cNvPr id="10" name="TextBox 9"/>
            <p:cNvSpPr txBox="1"/>
            <p:nvPr/>
          </p:nvSpPr>
          <p:spPr>
            <a:xfrm>
              <a:off x="6641573" y="1169882"/>
              <a:ext cx="11401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95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116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7816895" y="1358739"/>
              <a:ext cx="2796676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2939410" y="5230353"/>
            <a:ext cx="8664759" cy="307777"/>
            <a:chOff x="5086878" y="1169882"/>
            <a:chExt cx="5526693" cy="204655"/>
          </a:xfrm>
        </p:grpSpPr>
        <p:sp>
          <p:nvSpPr>
            <p:cNvPr id="14" name="TextBox 13"/>
            <p:cNvSpPr txBox="1"/>
            <p:nvPr/>
          </p:nvSpPr>
          <p:spPr>
            <a:xfrm>
              <a:off x="6641573" y="1169882"/>
              <a:ext cx="1067339" cy="204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117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140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66890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G:\2039x87119 PLATE 8,SAMPLE NO49 TO 96 29072016 RFQ-4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9655" y="28348"/>
            <a:ext cx="9479064" cy="59805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5"/>
          <p:cNvSpPr/>
          <p:nvPr/>
        </p:nvSpPr>
        <p:spPr>
          <a:xfrm>
            <a:off x="-21772" y="2733095"/>
            <a:ext cx="2721427" cy="584775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I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cLG08_RFQI4</a:t>
            </a:r>
          </a:p>
          <a:p>
            <a:r>
              <a:rPr lang="en-I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CPA 2039 x ICPL 87119 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2801131" y="952073"/>
            <a:ext cx="1041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PA 203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2998086" y="928067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CPL 8711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3740277" y="1169882"/>
            <a:ext cx="7961866" cy="500376"/>
            <a:chOff x="5086878" y="1169882"/>
            <a:chExt cx="5526693" cy="307777"/>
          </a:xfrm>
        </p:grpSpPr>
        <p:sp>
          <p:nvSpPr>
            <p:cNvPr id="10" name="TextBox 9"/>
            <p:cNvSpPr txBox="1"/>
            <p:nvPr/>
          </p:nvSpPr>
          <p:spPr>
            <a:xfrm>
              <a:off x="6641573" y="1169882"/>
              <a:ext cx="12047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141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164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7816895" y="1358739"/>
              <a:ext cx="2796676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3145971" y="4392131"/>
            <a:ext cx="7837715" cy="506407"/>
            <a:chOff x="5086878" y="1169882"/>
            <a:chExt cx="5526693" cy="204655"/>
          </a:xfrm>
        </p:grpSpPr>
        <p:sp>
          <p:nvSpPr>
            <p:cNvPr id="14" name="TextBox 13"/>
            <p:cNvSpPr txBox="1"/>
            <p:nvPr/>
          </p:nvSpPr>
          <p:spPr>
            <a:xfrm>
              <a:off x="6641573" y="1169882"/>
              <a:ext cx="1072481" cy="204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165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188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43011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2</TotalTime>
  <Words>116</Words>
  <Application>Microsoft Office PowerPoint</Application>
  <PresentationFormat>Custom</PresentationFormat>
  <Paragraphs>2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Saxena, Rachit (ICRISAT-IN)</cp:lastModifiedBy>
  <cp:revision>158</cp:revision>
  <dcterms:created xsi:type="dcterms:W3CDTF">2014-11-24T17:11:55Z</dcterms:created>
  <dcterms:modified xsi:type="dcterms:W3CDTF">2016-08-01T03:53:27Z</dcterms:modified>
</cp:coreProperties>
</file>